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86" d="100"/>
          <a:sy n="86" d="100"/>
        </p:scale>
        <p:origin x="1925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4057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7793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9133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8876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4597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50577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23126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5227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1443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62703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9535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69FAA-63DB-46D2-ADD4-10C2B9F85431}" type="datetimeFigureOut">
              <a:rPr lang="en-CA" smtClean="0"/>
              <a:t>2023-04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85AB4B-E394-459D-B981-554317FE89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2409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643445" y="817869"/>
            <a:ext cx="5254649" cy="8194875"/>
            <a:chOff x="643445" y="459044"/>
            <a:chExt cx="5254649" cy="819487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3445" y="721575"/>
              <a:ext cx="2469094" cy="2469094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0" y="721575"/>
              <a:ext cx="2469094" cy="246909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3445" y="3453200"/>
              <a:ext cx="2469094" cy="246909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29000" y="3453200"/>
              <a:ext cx="2469094" cy="246909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3445" y="6184825"/>
              <a:ext cx="2469094" cy="2469094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960698" y="463910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A</a:t>
              </a:r>
              <a:endParaRPr lang="en-CA" sz="11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20632" y="459044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B</a:t>
              </a:r>
              <a:endParaRPr lang="en-CA" sz="11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60698" y="3190669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C</a:t>
              </a:r>
              <a:endParaRPr lang="en-CA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520632" y="3190669"/>
              <a:ext cx="2712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D</a:t>
              </a:r>
              <a:endParaRPr lang="en-CA" sz="11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60900" y="5923215"/>
              <a:ext cx="2535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E</a:t>
              </a:r>
              <a:endParaRPr lang="en-CA" sz="1100" dirty="0"/>
            </a:p>
          </p:txBody>
        </p:sp>
      </p:grpSp>
      <p:sp>
        <p:nvSpPr>
          <p:cNvPr id="13" name="Rectangle 12"/>
          <p:cNvSpPr/>
          <p:nvPr/>
        </p:nvSpPr>
        <p:spPr>
          <a:xfrm>
            <a:off x="509811" y="47506"/>
            <a:ext cx="583837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Additional Figure 5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.  Q-Q plots of expected and observed associations between polymorphic SNPs and FHB traits across three years (</a:t>
            </a:r>
            <a:r>
              <a:rPr lang="en-US" sz="120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2017-2019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).</a:t>
            </a:r>
            <a:endParaRPr lang="en-CA" sz="1200" dirty="0"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9052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ra Serajazari</dc:creator>
  <cp:lastModifiedBy>Mitra Serajazari</cp:lastModifiedBy>
  <cp:revision>4</cp:revision>
  <dcterms:created xsi:type="dcterms:W3CDTF">2022-06-14T18:06:39Z</dcterms:created>
  <dcterms:modified xsi:type="dcterms:W3CDTF">2023-04-26T13:01:56Z</dcterms:modified>
</cp:coreProperties>
</file>